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4380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sper Søndenbroe" userId="f8776a83-b8c2-44e5-a16c-5099330b3ce0" providerId="ADAL" clId="{3EEC3353-E3D2-472A-9BD1-A05E9B88ACD0}"/>
    <pc:docChg chg="custSel addSld delSld modSld">
      <pc:chgData name="Casper Søndenbroe" userId="f8776a83-b8c2-44e5-a16c-5099330b3ce0" providerId="ADAL" clId="{3EEC3353-E3D2-472A-9BD1-A05E9B88ACD0}" dt="2025-12-01T12:16:19.628" v="8" actId="47"/>
      <pc:docMkLst>
        <pc:docMk/>
      </pc:docMkLst>
      <pc:sldChg chg="del">
        <pc:chgData name="Casper Søndenbroe" userId="f8776a83-b8c2-44e5-a16c-5099330b3ce0" providerId="ADAL" clId="{3EEC3353-E3D2-472A-9BD1-A05E9B88ACD0}" dt="2025-12-01T12:16:19.628" v="8" actId="47"/>
        <pc:sldMkLst>
          <pc:docMk/>
          <pc:sldMk cId="1178728739" sldId="264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63F187-BFD0-472B-82C5-C716981D6D73}" type="datetimeFigureOut">
              <a:rPr lang="da-DK" smtClean="0"/>
              <a:t>01-12-2025</a:t>
            </a:fld>
            <a:endParaRPr lang="da-DK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A5C0B6-63EE-4F94-9A09-8B0AB3ECA1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782501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E62B10-D70D-84B1-3FD2-BFD836EC79C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7D754DF-E736-7CD2-1C04-62FB46554AF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1C13727-F4C2-7E78-CCDB-C151A7F0D27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AA50DF-EA9B-593F-7476-673E979BDC5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A5C0B6-63EE-4F94-9A09-8B0AB3ECA14A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440187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406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825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927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139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970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139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3532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9941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179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0082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a-DK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4850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0F578F-DC4B-4A3C-92A3-221A8304D036}" type="datetimeFigureOut">
              <a:rPr lang="en-US" smtClean="0"/>
              <a:t>12/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C8989B-1907-48AD-9AEA-0D7FE815C1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711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D87155-DD2F-62EC-3EE7-FA88FCCC9C1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felt 3">
            <a:extLst>
              <a:ext uri="{FF2B5EF4-FFF2-40B4-BE49-F238E27FC236}">
                <a16:creationId xmlns:a16="http://schemas.microsoft.com/office/drawing/2014/main" id="{8B8E691B-6C5F-C00E-4795-02956E08E70B}"/>
              </a:ext>
            </a:extLst>
          </p:cNvPr>
          <p:cNvSpPr txBox="1"/>
          <p:nvPr/>
        </p:nvSpPr>
        <p:spPr>
          <a:xfrm>
            <a:off x="2153877" y="0"/>
            <a:ext cx="25502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/>
              <a:t>Supplemental table 2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6BA0DC14-DC39-2801-87B9-AD4440AC09C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9386932"/>
              </p:ext>
            </p:extLst>
          </p:nvPr>
        </p:nvGraphicFramePr>
        <p:xfrm>
          <a:off x="471488" y="3018461"/>
          <a:ext cx="5915023" cy="2540722"/>
        </p:xfrm>
        <a:graphic>
          <a:graphicData uri="http://schemas.openxmlformats.org/drawingml/2006/table">
            <a:tbl>
              <a:tblPr/>
              <a:tblGrid>
                <a:gridCol w="1666650">
                  <a:extLst>
                    <a:ext uri="{9D8B030D-6E8A-4147-A177-3AD203B41FA5}">
                      <a16:colId xmlns:a16="http://schemas.microsoft.com/office/drawing/2014/main" val="1194454106"/>
                    </a:ext>
                  </a:extLst>
                </a:gridCol>
                <a:gridCol w="640816">
                  <a:extLst>
                    <a:ext uri="{9D8B030D-6E8A-4147-A177-3AD203B41FA5}">
                      <a16:colId xmlns:a16="http://schemas.microsoft.com/office/drawing/2014/main" val="2801460118"/>
                    </a:ext>
                  </a:extLst>
                </a:gridCol>
                <a:gridCol w="640816">
                  <a:extLst>
                    <a:ext uri="{9D8B030D-6E8A-4147-A177-3AD203B41FA5}">
                      <a16:colId xmlns:a16="http://schemas.microsoft.com/office/drawing/2014/main" val="694714860"/>
                    </a:ext>
                  </a:extLst>
                </a:gridCol>
                <a:gridCol w="854422">
                  <a:extLst>
                    <a:ext uri="{9D8B030D-6E8A-4147-A177-3AD203B41FA5}">
                      <a16:colId xmlns:a16="http://schemas.microsoft.com/office/drawing/2014/main" val="2611514874"/>
                    </a:ext>
                  </a:extLst>
                </a:gridCol>
                <a:gridCol w="640816">
                  <a:extLst>
                    <a:ext uri="{9D8B030D-6E8A-4147-A177-3AD203B41FA5}">
                      <a16:colId xmlns:a16="http://schemas.microsoft.com/office/drawing/2014/main" val="657714167"/>
                    </a:ext>
                  </a:extLst>
                </a:gridCol>
                <a:gridCol w="640816">
                  <a:extLst>
                    <a:ext uri="{9D8B030D-6E8A-4147-A177-3AD203B41FA5}">
                      <a16:colId xmlns:a16="http://schemas.microsoft.com/office/drawing/2014/main" val="298565232"/>
                    </a:ext>
                  </a:extLst>
                </a:gridCol>
                <a:gridCol w="830687">
                  <a:extLst>
                    <a:ext uri="{9D8B030D-6E8A-4147-A177-3AD203B41FA5}">
                      <a16:colId xmlns:a16="http://schemas.microsoft.com/office/drawing/2014/main" val="3276187157"/>
                    </a:ext>
                  </a:extLst>
                </a:gridCol>
              </a:tblGrid>
              <a:tr h="157874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a-DK" sz="9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 to mid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42241155"/>
                  </a:ext>
                </a:extLst>
              </a:tr>
              <a:tr h="146823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a-DK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-EX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S-EX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0540914"/>
                  </a:ext>
                </a:extLst>
              </a:tr>
              <a:tr h="12629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ble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l-GR" sz="7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Δ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S [95%CI]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l-GR" sz="7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Δ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S [95%CI]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3972824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ximal voluntary contraction [Nm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 ± 14 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 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±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21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 [0.04 - 1.09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 ± 11 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 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±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20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8 [0.11 - 1.05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6356115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e of force development [Nm/s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± 28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8 ± 241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 [-0.09 - 0.94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 ± 66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6 ± 365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 [0.37 - 1.41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5717461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da-DK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uadriceps</a:t>
                      </a:r>
                      <a:r>
                        <a:rPr lang="da-DK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CSA [cm^2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± 4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 ± 2.4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 [-0.26 - 0.67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± 4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 ± 2.4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 [-0.27 - 0.61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5878437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pe I fCSA [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μ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^2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± 21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 ± 939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 [-0.48 - 0.53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± 19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 ± 992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 [-0.40 - 0.55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2010795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pe II fCSA [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μ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^2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± 17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 ± 815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 [-0.43 - 0.59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± 21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 ± 861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 [-0.34 - 0.62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0775840"/>
                  </a:ext>
                </a:extLst>
              </a:tr>
              <a:tr h="157874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a-DK" sz="9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 to post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7266067"/>
                  </a:ext>
                </a:extLst>
              </a:tr>
              <a:tr h="146823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da-DK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A-EX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S-EX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a-DK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73352520"/>
                  </a:ext>
                </a:extLst>
              </a:tr>
              <a:tr h="126299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ariable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l-GR" sz="7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Δ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S [95%CI]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%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l-GR" sz="7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Δ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da-DK" sz="700" b="0" i="1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ES [95%CI]</a:t>
                      </a:r>
                    </a:p>
                  </a:txBody>
                  <a:tcPr marL="7894" marR="7894" marT="789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9186569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ximal voluntary contraction [Nm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 ± 14 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 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±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21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 [0.07 - 1.07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± 14 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 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±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24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 [0.16 - 1.12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140139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te of force development [Nm/s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 ± 40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9 ± 258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 [0.17 - 1.19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 ± 99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6 ± 421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0 [0.55 - 1.66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8805250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uadriceps CSA [cm^2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± 3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 ±1.9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 [-0.28 - 0.65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± 4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0 ± 2.5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 [-0.28 - 0.60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1487863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pe I fCSA [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Aptos Narrow" panose="020B0004020202020204" pitchFamily="34" charset="0"/>
                        </a:rPr>
                        <a:t>μ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^2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± 19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7 ± 908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 [-0.16 - 0.85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 ± 20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3 ± 1062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 [-0.24 - 0.76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8160993"/>
                  </a:ext>
                </a:extLst>
              </a:tr>
              <a:tr h="167873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pe II fCSA [</a:t>
                      </a:r>
                      <a:r>
                        <a:rPr lang="el-GR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μ</a:t>
                      </a: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^2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 ± 21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6 ± 808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9 [-0.11 - 0.90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 ± 29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61 ± 942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da-DK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 [0.03 - 1.09]</a:t>
                      </a:r>
                    </a:p>
                  </a:txBody>
                  <a:tcPr marL="7894" marR="7894" marT="789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71596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39565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-tem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81</TotalTime>
  <Words>370</Words>
  <Application>Microsoft Office PowerPoint</Application>
  <PresentationFormat>A4 Paper (210x297 mm)</PresentationFormat>
  <Paragraphs>9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ptos Narrow</vt:lpstr>
      <vt:lpstr>Arial</vt:lpstr>
      <vt:lpstr>Calibri</vt:lpstr>
      <vt:lpstr>Office-te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Casper Søndenbroe</dc:creator>
  <cp:lastModifiedBy>Casper Søndenbroe</cp:lastModifiedBy>
  <cp:revision>41</cp:revision>
  <cp:lastPrinted>2025-03-21T12:49:11Z</cp:lastPrinted>
  <dcterms:created xsi:type="dcterms:W3CDTF">2024-12-16T19:08:23Z</dcterms:created>
  <dcterms:modified xsi:type="dcterms:W3CDTF">2025-12-01T12:16:20Z</dcterms:modified>
</cp:coreProperties>
</file>